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7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8F00"/>
    <a:srgbClr val="C852C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381"/>
    <p:restoredTop sz="82160" autoAdjust="0"/>
  </p:normalViewPr>
  <p:slideViewPr>
    <p:cSldViewPr snapToGrid="0" snapToObjects="1">
      <p:cViewPr varScale="1">
        <p:scale>
          <a:sx n="90" d="100"/>
          <a:sy n="90" d="100"/>
        </p:scale>
        <p:origin x="2724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../embeddings/oleObject1.bin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Correlation_bw_125_474_GEPS!$F$1</c:f>
              <c:strCache>
                <c:ptCount val="1"/>
                <c:pt idx="0">
                  <c:v>yp2_474GFL_GEPS_PLS</c:v>
                </c:pt>
              </c:strCache>
            </c:strRef>
          </c:tx>
          <c:spPr>
            <a:ln w="47625">
              <a:noFill/>
            </a:ln>
          </c:spPr>
          <c:marker>
            <c:symbol val="diamond"/>
            <c:size val="5"/>
          </c:marker>
          <c:trendline>
            <c:trendlineType val="linear"/>
            <c:dispRSqr val="1"/>
            <c:dispEq val="1"/>
            <c:trendlineLbl>
              <c:layout>
                <c:manualLayout>
                  <c:x val="-0.34272547584267754"/>
                  <c:y val="5.4566679510503251E-2"/>
                </c:manualLayout>
              </c:layout>
              <c:tx>
                <c:rich>
                  <a:bodyPr/>
                  <a:lstStyle/>
                  <a:p>
                    <a:pPr>
                      <a:defRPr sz="1100" b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r>
                      <a:rPr lang="en-US" sz="1100" b="0" i="1" baseline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y</a:t>
                    </a:r>
                    <a:r>
                      <a:rPr lang="en-US" sz="1100" b="0" baseline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= 1.1795x - 5.1918
R² = 0.7892</a:t>
                    </a:r>
                  </a:p>
                  <a:p>
                    <a:pPr>
                      <a:defRPr sz="1100" b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r>
                      <a:rPr lang="en-US" sz="1100" b="0" i="1" baseline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</a:t>
                    </a:r>
                    <a:r>
                      <a:rPr lang="en-US" sz="1100" b="0" baseline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= 0.8883</a:t>
                    </a:r>
                  </a:p>
                  <a:p>
                    <a:pPr>
                      <a:defRPr sz="1100" b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r>
                      <a:rPr lang="en-US" sz="1100" b="0" i="1" baseline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</a:t>
                    </a:r>
                    <a:r>
                      <a:rPr lang="en-US" sz="1100" b="0" baseline="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= 0.0000</a:t>
                    </a:r>
                    <a:endParaRPr lang="en-US" sz="1100" b="0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c:rich>
              </c:tx>
              <c:numFmt formatCode="General" sourceLinked="0"/>
            </c:trendlineLbl>
          </c:trendline>
          <c:xVal>
            <c:numRef>
              <c:f>Correlation_bw_125_474_GEPS!$C$2:$C$199</c:f>
              <c:numCache>
                <c:formatCode>General</c:formatCode>
                <c:ptCount val="198"/>
                <c:pt idx="0">
                  <c:v>30.58876939</c:v>
                </c:pt>
                <c:pt idx="1">
                  <c:v>28.838122469999998</c:v>
                </c:pt>
                <c:pt idx="2">
                  <c:v>29.544038050000001</c:v>
                </c:pt>
                <c:pt idx="3">
                  <c:v>28.473120309999999</c:v>
                </c:pt>
                <c:pt idx="4">
                  <c:v>27.067895740000001</c:v>
                </c:pt>
                <c:pt idx="5">
                  <c:v>28.225852490000001</c:v>
                </c:pt>
                <c:pt idx="6">
                  <c:v>29.196919090000002</c:v>
                </c:pt>
                <c:pt idx="7">
                  <c:v>28.32981015</c:v>
                </c:pt>
                <c:pt idx="8">
                  <c:v>30.619295390000001</c:v>
                </c:pt>
                <c:pt idx="9">
                  <c:v>29.08075272</c:v>
                </c:pt>
                <c:pt idx="10">
                  <c:v>30.608342690000001</c:v>
                </c:pt>
                <c:pt idx="11">
                  <c:v>29.724914510000001</c:v>
                </c:pt>
                <c:pt idx="12">
                  <c:v>28.310393449999999</c:v>
                </c:pt>
                <c:pt idx="13">
                  <c:v>27.981687180000002</c:v>
                </c:pt>
                <c:pt idx="14">
                  <c:v>29.025178440000001</c:v>
                </c:pt>
                <c:pt idx="15">
                  <c:v>29.228873539999999</c:v>
                </c:pt>
                <c:pt idx="16">
                  <c:v>29.36324978</c:v>
                </c:pt>
                <c:pt idx="17">
                  <c:v>27.110559349999999</c:v>
                </c:pt>
                <c:pt idx="18">
                  <c:v>28.806005939999999</c:v>
                </c:pt>
                <c:pt idx="19">
                  <c:v>28.685526500000002</c:v>
                </c:pt>
                <c:pt idx="20">
                  <c:v>27.880126260000001</c:v>
                </c:pt>
                <c:pt idx="21">
                  <c:v>28.801544270000001</c:v>
                </c:pt>
                <c:pt idx="22">
                  <c:v>28.306241849999999</c:v>
                </c:pt>
                <c:pt idx="23">
                  <c:v>29.51300616</c:v>
                </c:pt>
                <c:pt idx="24">
                  <c:v>28.719361989999999</c:v>
                </c:pt>
                <c:pt idx="25">
                  <c:v>27.59764384</c:v>
                </c:pt>
                <c:pt idx="26">
                  <c:v>28.876263739999999</c:v>
                </c:pt>
                <c:pt idx="27">
                  <c:v>28.322804000000001</c:v>
                </c:pt>
                <c:pt idx="28">
                  <c:v>28.329728849999999</c:v>
                </c:pt>
                <c:pt idx="29">
                  <c:v>26.06321728</c:v>
                </c:pt>
                <c:pt idx="30">
                  <c:v>29.585643650000002</c:v>
                </c:pt>
                <c:pt idx="31">
                  <c:v>27.130712890000002</c:v>
                </c:pt>
                <c:pt idx="32">
                  <c:v>27.345968880000001</c:v>
                </c:pt>
                <c:pt idx="33">
                  <c:v>30.412821529999999</c:v>
                </c:pt>
                <c:pt idx="34">
                  <c:v>29.627129750000002</c:v>
                </c:pt>
                <c:pt idx="35">
                  <c:v>28.209167229999998</c:v>
                </c:pt>
                <c:pt idx="36">
                  <c:v>29.68815382</c:v>
                </c:pt>
                <c:pt idx="37">
                  <c:v>30.590021</c:v>
                </c:pt>
                <c:pt idx="38">
                  <c:v>31.002624189999999</c:v>
                </c:pt>
                <c:pt idx="39">
                  <c:v>29.822172519999999</c:v>
                </c:pt>
                <c:pt idx="40">
                  <c:v>30.014705209999999</c:v>
                </c:pt>
                <c:pt idx="41">
                  <c:v>29.481730760000001</c:v>
                </c:pt>
                <c:pt idx="42">
                  <c:v>27.555131920000001</c:v>
                </c:pt>
                <c:pt idx="43">
                  <c:v>29.18909871</c:v>
                </c:pt>
                <c:pt idx="44">
                  <c:v>28.43465162</c:v>
                </c:pt>
                <c:pt idx="45">
                  <c:v>28.42600135</c:v>
                </c:pt>
                <c:pt idx="46">
                  <c:v>30.91055617</c:v>
                </c:pt>
                <c:pt idx="47">
                  <c:v>28.496935560000001</c:v>
                </c:pt>
                <c:pt idx="48">
                  <c:v>25.76270341</c:v>
                </c:pt>
                <c:pt idx="49">
                  <c:v>30.26686861</c:v>
                </c:pt>
                <c:pt idx="50">
                  <c:v>28.47265887</c:v>
                </c:pt>
                <c:pt idx="51">
                  <c:v>27.186951440000001</c:v>
                </c:pt>
                <c:pt idx="52">
                  <c:v>30.375744319999999</c:v>
                </c:pt>
                <c:pt idx="53">
                  <c:v>29.829620609999999</c:v>
                </c:pt>
                <c:pt idx="54">
                  <c:v>30.389113680000001</c:v>
                </c:pt>
                <c:pt idx="55">
                  <c:v>26.298436039999999</c:v>
                </c:pt>
                <c:pt idx="56">
                  <c:v>28.669788629999999</c:v>
                </c:pt>
                <c:pt idx="57">
                  <c:v>29.161645459999999</c:v>
                </c:pt>
                <c:pt idx="58">
                  <c:v>31.396053210000002</c:v>
                </c:pt>
                <c:pt idx="59">
                  <c:v>27.369524269999999</c:v>
                </c:pt>
                <c:pt idx="60">
                  <c:v>27.900100200000001</c:v>
                </c:pt>
                <c:pt idx="61">
                  <c:v>27.556869120000002</c:v>
                </c:pt>
                <c:pt idx="62">
                  <c:v>27.443957959999999</c:v>
                </c:pt>
                <c:pt idx="63">
                  <c:v>29.946981579999999</c:v>
                </c:pt>
                <c:pt idx="64">
                  <c:v>29.344493830000001</c:v>
                </c:pt>
                <c:pt idx="65">
                  <c:v>27.272287720000001</c:v>
                </c:pt>
                <c:pt idx="66">
                  <c:v>27.2246442</c:v>
                </c:pt>
                <c:pt idx="67">
                  <c:v>30.92629853</c:v>
                </c:pt>
                <c:pt idx="68">
                  <c:v>30.484376520000001</c:v>
                </c:pt>
                <c:pt idx="69">
                  <c:v>26.999414659999999</c:v>
                </c:pt>
                <c:pt idx="70">
                  <c:v>31.247029019999999</c:v>
                </c:pt>
                <c:pt idx="71">
                  <c:v>29.85201163</c:v>
                </c:pt>
                <c:pt idx="72">
                  <c:v>28.497134070000001</c:v>
                </c:pt>
                <c:pt idx="73">
                  <c:v>28.124650769999999</c:v>
                </c:pt>
                <c:pt idx="74">
                  <c:v>29.209916199999999</c:v>
                </c:pt>
                <c:pt idx="75">
                  <c:v>27.294153269999999</c:v>
                </c:pt>
                <c:pt idx="76">
                  <c:v>28.335527769999999</c:v>
                </c:pt>
                <c:pt idx="77">
                  <c:v>28.882696580000001</c:v>
                </c:pt>
                <c:pt idx="78">
                  <c:v>28.15216715</c:v>
                </c:pt>
                <c:pt idx="79">
                  <c:v>29.32916234</c:v>
                </c:pt>
                <c:pt idx="80">
                  <c:v>28.34333436</c:v>
                </c:pt>
                <c:pt idx="81">
                  <c:v>27.81430383</c:v>
                </c:pt>
                <c:pt idx="82">
                  <c:v>28.736904790000001</c:v>
                </c:pt>
                <c:pt idx="83">
                  <c:v>30.546527659999999</c:v>
                </c:pt>
                <c:pt idx="84">
                  <c:v>29.56724573</c:v>
                </c:pt>
                <c:pt idx="85">
                  <c:v>29.26385385</c:v>
                </c:pt>
                <c:pt idx="86">
                  <c:v>30.871912559999998</c:v>
                </c:pt>
                <c:pt idx="87">
                  <c:v>26.97823833</c:v>
                </c:pt>
                <c:pt idx="88">
                  <c:v>29.252487089999999</c:v>
                </c:pt>
                <c:pt idx="89">
                  <c:v>28.579191040000001</c:v>
                </c:pt>
                <c:pt idx="90">
                  <c:v>28.521355880000002</c:v>
                </c:pt>
                <c:pt idx="91">
                  <c:v>27.596485260000001</c:v>
                </c:pt>
                <c:pt idx="92">
                  <c:v>31.55425447</c:v>
                </c:pt>
                <c:pt idx="93">
                  <c:v>28.984488720000002</c:v>
                </c:pt>
                <c:pt idx="94">
                  <c:v>29.735540589999999</c:v>
                </c:pt>
                <c:pt idx="95">
                  <c:v>27.968011650000001</c:v>
                </c:pt>
                <c:pt idx="96">
                  <c:v>28.037478499999999</c:v>
                </c:pt>
                <c:pt idx="97">
                  <c:v>30.541303039999999</c:v>
                </c:pt>
                <c:pt idx="98">
                  <c:v>29.503256990000001</c:v>
                </c:pt>
                <c:pt idx="99">
                  <c:v>28.77263993</c:v>
                </c:pt>
                <c:pt idx="100">
                  <c:v>27.74732762</c:v>
                </c:pt>
                <c:pt idx="101">
                  <c:v>28.81181368</c:v>
                </c:pt>
                <c:pt idx="102">
                  <c:v>28.06477568</c:v>
                </c:pt>
                <c:pt idx="103">
                  <c:v>27.740309400000001</c:v>
                </c:pt>
                <c:pt idx="104">
                  <c:v>29.634600280000001</c:v>
                </c:pt>
                <c:pt idx="105">
                  <c:v>28.810084029999999</c:v>
                </c:pt>
                <c:pt idx="106">
                  <c:v>27.79523506</c:v>
                </c:pt>
                <c:pt idx="107">
                  <c:v>26.873451800000002</c:v>
                </c:pt>
                <c:pt idx="108">
                  <c:v>29.062162879999999</c:v>
                </c:pt>
                <c:pt idx="109">
                  <c:v>27.783364729999999</c:v>
                </c:pt>
                <c:pt idx="110">
                  <c:v>27.8876569</c:v>
                </c:pt>
                <c:pt idx="111">
                  <c:v>29.140507759999998</c:v>
                </c:pt>
                <c:pt idx="112">
                  <c:v>28.498719579999999</c:v>
                </c:pt>
                <c:pt idx="113">
                  <c:v>27.94230349</c:v>
                </c:pt>
                <c:pt idx="114">
                  <c:v>29.618973050000001</c:v>
                </c:pt>
                <c:pt idx="115">
                  <c:v>28.042277850000001</c:v>
                </c:pt>
                <c:pt idx="116">
                  <c:v>27.8219423</c:v>
                </c:pt>
                <c:pt idx="117">
                  <c:v>29.95524206</c:v>
                </c:pt>
                <c:pt idx="118">
                  <c:v>30.102328960000001</c:v>
                </c:pt>
                <c:pt idx="119">
                  <c:v>28.573397589999999</c:v>
                </c:pt>
                <c:pt idx="120">
                  <c:v>29.27675915</c:v>
                </c:pt>
                <c:pt idx="121">
                  <c:v>27.4279592</c:v>
                </c:pt>
                <c:pt idx="122">
                  <c:v>29.979595660000001</c:v>
                </c:pt>
                <c:pt idx="123">
                  <c:v>28.458702349999999</c:v>
                </c:pt>
                <c:pt idx="124">
                  <c:v>27.673101370000001</c:v>
                </c:pt>
                <c:pt idx="125">
                  <c:v>27.726880260000001</c:v>
                </c:pt>
                <c:pt idx="126">
                  <c:v>27.792099279999999</c:v>
                </c:pt>
                <c:pt idx="127">
                  <c:v>28.725151230000002</c:v>
                </c:pt>
                <c:pt idx="128">
                  <c:v>27.624261990000001</c:v>
                </c:pt>
                <c:pt idx="129">
                  <c:v>28.662740079999999</c:v>
                </c:pt>
                <c:pt idx="130">
                  <c:v>30.289630880000001</c:v>
                </c:pt>
                <c:pt idx="131">
                  <c:v>28.344723439999999</c:v>
                </c:pt>
                <c:pt idx="132">
                  <c:v>28.765182970000001</c:v>
                </c:pt>
                <c:pt idx="133">
                  <c:v>27.372487249999999</c:v>
                </c:pt>
                <c:pt idx="134">
                  <c:v>27.8384149</c:v>
                </c:pt>
                <c:pt idx="135">
                  <c:v>28.807656309999999</c:v>
                </c:pt>
                <c:pt idx="136">
                  <c:v>28.462768950000001</c:v>
                </c:pt>
                <c:pt idx="137">
                  <c:v>29.586682190000001</c:v>
                </c:pt>
                <c:pt idx="138">
                  <c:v>30.78353139</c:v>
                </c:pt>
                <c:pt idx="139">
                  <c:v>28.9498304</c:v>
                </c:pt>
                <c:pt idx="140">
                  <c:v>28.902053250000002</c:v>
                </c:pt>
                <c:pt idx="141">
                  <c:v>26.84737531</c:v>
                </c:pt>
                <c:pt idx="142">
                  <c:v>29.259806640000001</c:v>
                </c:pt>
                <c:pt idx="143">
                  <c:v>27.17343777</c:v>
                </c:pt>
                <c:pt idx="144">
                  <c:v>27.322090710000001</c:v>
                </c:pt>
                <c:pt idx="145">
                  <c:v>28.856256590000001</c:v>
                </c:pt>
                <c:pt idx="146">
                  <c:v>28.799847759999999</c:v>
                </c:pt>
                <c:pt idx="147">
                  <c:v>27.393608</c:v>
                </c:pt>
                <c:pt idx="148">
                  <c:v>29.72842975</c:v>
                </c:pt>
                <c:pt idx="149">
                  <c:v>30.685374469999999</c:v>
                </c:pt>
                <c:pt idx="150">
                  <c:v>29.36385241</c:v>
                </c:pt>
                <c:pt idx="151">
                  <c:v>29.59874022</c:v>
                </c:pt>
                <c:pt idx="152">
                  <c:v>29.489516290000001</c:v>
                </c:pt>
                <c:pt idx="153">
                  <c:v>27.469374940000002</c:v>
                </c:pt>
                <c:pt idx="154">
                  <c:v>28.32639777</c:v>
                </c:pt>
                <c:pt idx="155">
                  <c:v>28.551242259999999</c:v>
                </c:pt>
                <c:pt idx="156">
                  <c:v>30.82669108</c:v>
                </c:pt>
                <c:pt idx="157">
                  <c:v>28.375364170000001</c:v>
                </c:pt>
                <c:pt idx="158">
                  <c:v>27.716064169999999</c:v>
                </c:pt>
                <c:pt idx="159">
                  <c:v>28.557847779999999</c:v>
                </c:pt>
                <c:pt idx="160">
                  <c:v>30.3361132</c:v>
                </c:pt>
                <c:pt idx="161">
                  <c:v>29.570392460000001</c:v>
                </c:pt>
                <c:pt idx="162">
                  <c:v>26.8652649</c:v>
                </c:pt>
                <c:pt idx="163">
                  <c:v>29.027891619999998</c:v>
                </c:pt>
                <c:pt idx="164">
                  <c:v>28.47964434</c:v>
                </c:pt>
                <c:pt idx="165">
                  <c:v>28.348444140000002</c:v>
                </c:pt>
                <c:pt idx="166">
                  <c:v>30.73941683</c:v>
                </c:pt>
                <c:pt idx="167">
                  <c:v>27.970249729999999</c:v>
                </c:pt>
                <c:pt idx="168">
                  <c:v>28.17366024</c:v>
                </c:pt>
                <c:pt idx="169">
                  <c:v>29.617363739999998</c:v>
                </c:pt>
                <c:pt idx="170">
                  <c:v>27.962950679999999</c:v>
                </c:pt>
                <c:pt idx="171">
                  <c:v>27.830218070000001</c:v>
                </c:pt>
                <c:pt idx="172">
                  <c:v>29.917570950000002</c:v>
                </c:pt>
                <c:pt idx="173">
                  <c:v>26.730276159999999</c:v>
                </c:pt>
                <c:pt idx="174">
                  <c:v>29.145370939999999</c:v>
                </c:pt>
                <c:pt idx="175">
                  <c:v>27.379855190000001</c:v>
                </c:pt>
                <c:pt idx="176">
                  <c:v>27.75307682</c:v>
                </c:pt>
                <c:pt idx="177">
                  <c:v>28.550645169999999</c:v>
                </c:pt>
                <c:pt idx="178">
                  <c:v>29.878760549999999</c:v>
                </c:pt>
                <c:pt idx="179">
                  <c:v>29.534085839999999</c:v>
                </c:pt>
                <c:pt idx="180">
                  <c:v>29.913333909999999</c:v>
                </c:pt>
                <c:pt idx="181">
                  <c:v>28.574658960000001</c:v>
                </c:pt>
                <c:pt idx="182">
                  <c:v>29.019170890000002</c:v>
                </c:pt>
                <c:pt idx="183">
                  <c:v>28.771035990000001</c:v>
                </c:pt>
                <c:pt idx="184">
                  <c:v>29.844781229999999</c:v>
                </c:pt>
                <c:pt idx="185">
                  <c:v>28.111215319999999</c:v>
                </c:pt>
                <c:pt idx="186">
                  <c:v>29.13831879</c:v>
                </c:pt>
                <c:pt idx="187">
                  <c:v>28.7185992</c:v>
                </c:pt>
                <c:pt idx="188">
                  <c:v>29.949746180000002</c:v>
                </c:pt>
                <c:pt idx="189">
                  <c:v>28.161340419999998</c:v>
                </c:pt>
                <c:pt idx="190">
                  <c:v>30.345094599999999</c:v>
                </c:pt>
                <c:pt idx="191">
                  <c:v>27.26632687</c:v>
                </c:pt>
                <c:pt idx="192">
                  <c:v>30.242971690000001</c:v>
                </c:pt>
                <c:pt idx="193">
                  <c:v>26.623151530000001</c:v>
                </c:pt>
                <c:pt idx="194">
                  <c:v>27.52102537</c:v>
                </c:pt>
                <c:pt idx="195">
                  <c:v>29.042436429999999</c:v>
                </c:pt>
                <c:pt idx="196">
                  <c:v>29.213978019999999</c:v>
                </c:pt>
                <c:pt idx="197">
                  <c:v>27.937103180000001</c:v>
                </c:pt>
              </c:numCache>
            </c:numRef>
          </c:xVal>
          <c:yVal>
            <c:numRef>
              <c:f>Correlation_bw_125_474_GEPS!$F$2:$F$199</c:f>
              <c:numCache>
                <c:formatCode>General</c:formatCode>
                <c:ptCount val="198"/>
                <c:pt idx="0">
                  <c:v>29.487757779999999</c:v>
                </c:pt>
                <c:pt idx="1">
                  <c:v>29.052664870000001</c:v>
                </c:pt>
                <c:pt idx="2">
                  <c:v>28.569516149999998</c:v>
                </c:pt>
                <c:pt idx="3">
                  <c:v>27.470048429999999</c:v>
                </c:pt>
                <c:pt idx="4">
                  <c:v>26.97760272</c:v>
                </c:pt>
                <c:pt idx="5">
                  <c:v>27.70636885</c:v>
                </c:pt>
                <c:pt idx="6">
                  <c:v>29.290275749999999</c:v>
                </c:pt>
                <c:pt idx="7">
                  <c:v>28.457315730000001</c:v>
                </c:pt>
                <c:pt idx="8">
                  <c:v>30.293054819999998</c:v>
                </c:pt>
                <c:pt idx="9">
                  <c:v>29.684028940000001</c:v>
                </c:pt>
                <c:pt idx="10">
                  <c:v>31.724338490000001</c:v>
                </c:pt>
                <c:pt idx="11">
                  <c:v>30.832901240000002</c:v>
                </c:pt>
                <c:pt idx="12">
                  <c:v>28.461661889999998</c:v>
                </c:pt>
                <c:pt idx="13">
                  <c:v>28.209015879999999</c:v>
                </c:pt>
                <c:pt idx="14">
                  <c:v>28.779626539999999</c:v>
                </c:pt>
                <c:pt idx="15">
                  <c:v>28.91958502</c:v>
                </c:pt>
                <c:pt idx="16">
                  <c:v>29.176876920000002</c:v>
                </c:pt>
                <c:pt idx="17">
                  <c:v>26.06601912</c:v>
                </c:pt>
                <c:pt idx="18">
                  <c:v>27.940985550000001</c:v>
                </c:pt>
                <c:pt idx="19">
                  <c:v>29.014652160000001</c:v>
                </c:pt>
                <c:pt idx="20">
                  <c:v>27.3717504</c:v>
                </c:pt>
                <c:pt idx="21">
                  <c:v>28.43957558</c:v>
                </c:pt>
                <c:pt idx="22">
                  <c:v>28.875821269999999</c:v>
                </c:pt>
                <c:pt idx="23">
                  <c:v>30.5024388</c:v>
                </c:pt>
                <c:pt idx="24">
                  <c:v>29.14172056</c:v>
                </c:pt>
                <c:pt idx="25">
                  <c:v>27.520308920000002</c:v>
                </c:pt>
                <c:pt idx="26">
                  <c:v>29.112782639999999</c:v>
                </c:pt>
                <c:pt idx="27">
                  <c:v>28.084594679999999</c:v>
                </c:pt>
                <c:pt idx="28">
                  <c:v>27.4557185</c:v>
                </c:pt>
                <c:pt idx="29">
                  <c:v>26.775142129999999</c:v>
                </c:pt>
                <c:pt idx="30">
                  <c:v>28.79965576</c:v>
                </c:pt>
                <c:pt idx="31">
                  <c:v>26.373306400000001</c:v>
                </c:pt>
                <c:pt idx="32">
                  <c:v>27.415205</c:v>
                </c:pt>
                <c:pt idx="33">
                  <c:v>30.587954320000001</c:v>
                </c:pt>
                <c:pt idx="34">
                  <c:v>29.891188679999999</c:v>
                </c:pt>
                <c:pt idx="35">
                  <c:v>28.317396469999998</c:v>
                </c:pt>
                <c:pt idx="36">
                  <c:v>29.210248350000001</c:v>
                </c:pt>
                <c:pt idx="37">
                  <c:v>30.665128289999998</c:v>
                </c:pt>
                <c:pt idx="38">
                  <c:v>31.566120359999999</c:v>
                </c:pt>
                <c:pt idx="39">
                  <c:v>30.68532394</c:v>
                </c:pt>
                <c:pt idx="40">
                  <c:v>29.63071635</c:v>
                </c:pt>
                <c:pt idx="41">
                  <c:v>28.13864113</c:v>
                </c:pt>
                <c:pt idx="42">
                  <c:v>27.481781789999999</c:v>
                </c:pt>
                <c:pt idx="43">
                  <c:v>30.389971809999999</c:v>
                </c:pt>
                <c:pt idx="44">
                  <c:v>27.918591459999998</c:v>
                </c:pt>
                <c:pt idx="45">
                  <c:v>28.43214631</c:v>
                </c:pt>
                <c:pt idx="46">
                  <c:v>31.719127879999998</c:v>
                </c:pt>
                <c:pt idx="47">
                  <c:v>28.998951959999999</c:v>
                </c:pt>
                <c:pt idx="48">
                  <c:v>25.884115569999999</c:v>
                </c:pt>
                <c:pt idx="49">
                  <c:v>30.466565020000001</c:v>
                </c:pt>
                <c:pt idx="50">
                  <c:v>29.012402470000001</c:v>
                </c:pt>
                <c:pt idx="51">
                  <c:v>27.830876249999999</c:v>
                </c:pt>
                <c:pt idx="52">
                  <c:v>29.888451419999999</c:v>
                </c:pt>
                <c:pt idx="53">
                  <c:v>29.401632150000001</c:v>
                </c:pt>
                <c:pt idx="54">
                  <c:v>30.331503560000002</c:v>
                </c:pt>
                <c:pt idx="55">
                  <c:v>25.16838229</c:v>
                </c:pt>
                <c:pt idx="56">
                  <c:v>28.451130150000001</c:v>
                </c:pt>
                <c:pt idx="57">
                  <c:v>28.998696169999999</c:v>
                </c:pt>
                <c:pt idx="58">
                  <c:v>32.193300290000003</c:v>
                </c:pt>
                <c:pt idx="59">
                  <c:v>28.2354822</c:v>
                </c:pt>
                <c:pt idx="60">
                  <c:v>28.039100850000001</c:v>
                </c:pt>
                <c:pt idx="61">
                  <c:v>27.83848485</c:v>
                </c:pt>
                <c:pt idx="62">
                  <c:v>27.43535327</c:v>
                </c:pt>
                <c:pt idx="63">
                  <c:v>32.471291020000002</c:v>
                </c:pt>
                <c:pt idx="64">
                  <c:v>29.96848863</c:v>
                </c:pt>
                <c:pt idx="65">
                  <c:v>25.855492210000001</c:v>
                </c:pt>
                <c:pt idx="66">
                  <c:v>27.081645859999998</c:v>
                </c:pt>
                <c:pt idx="67">
                  <c:v>30.96479686</c:v>
                </c:pt>
                <c:pt idx="68">
                  <c:v>30.323338140000001</c:v>
                </c:pt>
                <c:pt idx="69">
                  <c:v>27.68725332</c:v>
                </c:pt>
                <c:pt idx="70">
                  <c:v>30.93469576</c:v>
                </c:pt>
                <c:pt idx="71">
                  <c:v>30.052235719999999</c:v>
                </c:pt>
                <c:pt idx="72">
                  <c:v>29.43324883</c:v>
                </c:pt>
                <c:pt idx="73">
                  <c:v>28.21657016</c:v>
                </c:pt>
                <c:pt idx="74">
                  <c:v>28.725299759999999</c:v>
                </c:pt>
                <c:pt idx="75">
                  <c:v>28.311644399999999</c:v>
                </c:pt>
                <c:pt idx="76">
                  <c:v>28.618007370000001</c:v>
                </c:pt>
                <c:pt idx="77">
                  <c:v>30.764334909999999</c:v>
                </c:pt>
                <c:pt idx="78">
                  <c:v>28.198499890000001</c:v>
                </c:pt>
                <c:pt idx="79">
                  <c:v>29.683840020000002</c:v>
                </c:pt>
                <c:pt idx="80">
                  <c:v>28.817931789999999</c:v>
                </c:pt>
                <c:pt idx="81">
                  <c:v>27.139782499999999</c:v>
                </c:pt>
                <c:pt idx="82">
                  <c:v>27.915074010000001</c:v>
                </c:pt>
                <c:pt idx="83">
                  <c:v>31.280372979999999</c:v>
                </c:pt>
                <c:pt idx="84">
                  <c:v>30.223943869999999</c:v>
                </c:pt>
                <c:pt idx="85">
                  <c:v>29.602178080000002</c:v>
                </c:pt>
                <c:pt idx="86">
                  <c:v>31.611803330000001</c:v>
                </c:pt>
                <c:pt idx="87">
                  <c:v>25.660910739999998</c:v>
                </c:pt>
                <c:pt idx="88">
                  <c:v>29.441819039999999</c:v>
                </c:pt>
                <c:pt idx="89">
                  <c:v>29.140437219999999</c:v>
                </c:pt>
                <c:pt idx="90">
                  <c:v>28.654436149999999</c:v>
                </c:pt>
                <c:pt idx="91">
                  <c:v>26.768254259999999</c:v>
                </c:pt>
                <c:pt idx="92">
                  <c:v>32.304736390000002</c:v>
                </c:pt>
                <c:pt idx="93">
                  <c:v>28.252706809999999</c:v>
                </c:pt>
                <c:pt idx="94">
                  <c:v>31.09652925</c:v>
                </c:pt>
                <c:pt idx="95">
                  <c:v>28.156241130000002</c:v>
                </c:pt>
                <c:pt idx="96">
                  <c:v>28.24471582</c:v>
                </c:pt>
                <c:pt idx="97">
                  <c:v>30.35952013</c:v>
                </c:pt>
                <c:pt idx="98">
                  <c:v>28.9884968</c:v>
                </c:pt>
                <c:pt idx="99">
                  <c:v>28.648230059999999</c:v>
                </c:pt>
                <c:pt idx="100">
                  <c:v>28.120146089999999</c:v>
                </c:pt>
                <c:pt idx="101">
                  <c:v>28.3597684</c:v>
                </c:pt>
                <c:pt idx="102">
                  <c:v>28.95348942</c:v>
                </c:pt>
                <c:pt idx="103">
                  <c:v>26.573127509999999</c:v>
                </c:pt>
                <c:pt idx="104">
                  <c:v>29.210141050000001</c:v>
                </c:pt>
                <c:pt idx="105">
                  <c:v>28.590387679999999</c:v>
                </c:pt>
                <c:pt idx="106">
                  <c:v>26.994422119999999</c:v>
                </c:pt>
                <c:pt idx="107">
                  <c:v>27.24781784</c:v>
                </c:pt>
                <c:pt idx="108">
                  <c:v>29.47018546</c:v>
                </c:pt>
                <c:pt idx="109">
                  <c:v>26.765257120000001</c:v>
                </c:pt>
                <c:pt idx="110">
                  <c:v>27.209622499999998</c:v>
                </c:pt>
                <c:pt idx="111">
                  <c:v>30.58216822</c:v>
                </c:pt>
                <c:pt idx="112">
                  <c:v>27.680326269999998</c:v>
                </c:pt>
                <c:pt idx="113">
                  <c:v>27.963388070000001</c:v>
                </c:pt>
                <c:pt idx="114">
                  <c:v>30.511131089999999</c:v>
                </c:pt>
                <c:pt idx="115">
                  <c:v>27.979936439999999</c:v>
                </c:pt>
                <c:pt idx="116">
                  <c:v>28.328242270000001</c:v>
                </c:pt>
                <c:pt idx="117">
                  <c:v>29.305765340000001</c:v>
                </c:pt>
                <c:pt idx="118">
                  <c:v>30.651130250000001</c:v>
                </c:pt>
                <c:pt idx="119">
                  <c:v>27.890089230000001</c:v>
                </c:pt>
                <c:pt idx="120">
                  <c:v>29.300595229999999</c:v>
                </c:pt>
                <c:pt idx="121">
                  <c:v>27.767338859999999</c:v>
                </c:pt>
                <c:pt idx="122">
                  <c:v>30.711350150000001</c:v>
                </c:pt>
                <c:pt idx="123">
                  <c:v>27.708256380000002</c:v>
                </c:pt>
                <c:pt idx="124">
                  <c:v>27.97448867</c:v>
                </c:pt>
                <c:pt idx="125">
                  <c:v>27.895599390000001</c:v>
                </c:pt>
                <c:pt idx="126">
                  <c:v>26.079347859999999</c:v>
                </c:pt>
                <c:pt idx="127">
                  <c:v>27.893833829999998</c:v>
                </c:pt>
                <c:pt idx="128">
                  <c:v>27.589132209999999</c:v>
                </c:pt>
                <c:pt idx="129">
                  <c:v>28.767866489999999</c:v>
                </c:pt>
                <c:pt idx="130">
                  <c:v>30.182404030000001</c:v>
                </c:pt>
                <c:pt idx="131">
                  <c:v>26.70638696</c:v>
                </c:pt>
                <c:pt idx="132">
                  <c:v>29.170469409999999</c:v>
                </c:pt>
                <c:pt idx="133">
                  <c:v>28.455358950000001</c:v>
                </c:pt>
                <c:pt idx="134">
                  <c:v>26.710189410000002</c:v>
                </c:pt>
                <c:pt idx="135">
                  <c:v>28.747979699999998</c:v>
                </c:pt>
                <c:pt idx="136">
                  <c:v>26.89467136</c:v>
                </c:pt>
                <c:pt idx="137">
                  <c:v>29.340994590000001</c:v>
                </c:pt>
                <c:pt idx="138">
                  <c:v>32.413110459999999</c:v>
                </c:pt>
                <c:pt idx="139">
                  <c:v>29.499828359999999</c:v>
                </c:pt>
                <c:pt idx="140">
                  <c:v>28.31971485</c:v>
                </c:pt>
                <c:pt idx="141">
                  <c:v>24.99075002</c:v>
                </c:pt>
                <c:pt idx="142">
                  <c:v>29.634928380000002</c:v>
                </c:pt>
                <c:pt idx="143">
                  <c:v>26.49359467</c:v>
                </c:pt>
                <c:pt idx="144">
                  <c:v>26.644339720000001</c:v>
                </c:pt>
                <c:pt idx="145">
                  <c:v>29.05877628</c:v>
                </c:pt>
                <c:pt idx="146">
                  <c:v>27.481046490000001</c:v>
                </c:pt>
                <c:pt idx="147">
                  <c:v>28.44675033</c:v>
                </c:pt>
                <c:pt idx="148">
                  <c:v>29.32850565</c:v>
                </c:pt>
                <c:pt idx="149">
                  <c:v>30.949527</c:v>
                </c:pt>
                <c:pt idx="150">
                  <c:v>29.154888960000001</c:v>
                </c:pt>
                <c:pt idx="151">
                  <c:v>29.398712329999999</c:v>
                </c:pt>
                <c:pt idx="152">
                  <c:v>30.44517033</c:v>
                </c:pt>
                <c:pt idx="153">
                  <c:v>27.329897540000001</c:v>
                </c:pt>
                <c:pt idx="154">
                  <c:v>27.953629039999999</c:v>
                </c:pt>
                <c:pt idx="155">
                  <c:v>26.883678150000001</c:v>
                </c:pt>
                <c:pt idx="156">
                  <c:v>31.157851740000002</c:v>
                </c:pt>
                <c:pt idx="157">
                  <c:v>28.379835270000001</c:v>
                </c:pt>
                <c:pt idx="158">
                  <c:v>27.307471249999999</c:v>
                </c:pt>
                <c:pt idx="159">
                  <c:v>29.313276949999999</c:v>
                </c:pt>
                <c:pt idx="160">
                  <c:v>31.079649459999999</c:v>
                </c:pt>
                <c:pt idx="161">
                  <c:v>29.39834845</c:v>
                </c:pt>
                <c:pt idx="162">
                  <c:v>25.780558840000001</c:v>
                </c:pt>
                <c:pt idx="163">
                  <c:v>29.515421589999999</c:v>
                </c:pt>
                <c:pt idx="164">
                  <c:v>28.439662420000001</c:v>
                </c:pt>
                <c:pt idx="165">
                  <c:v>28.35507776</c:v>
                </c:pt>
                <c:pt idx="166">
                  <c:v>30.840385869999999</c:v>
                </c:pt>
                <c:pt idx="167">
                  <c:v>26.89468591</c:v>
                </c:pt>
                <c:pt idx="168">
                  <c:v>27.950020670000001</c:v>
                </c:pt>
                <c:pt idx="169">
                  <c:v>28.8590898</c:v>
                </c:pt>
                <c:pt idx="170">
                  <c:v>26.838649749999998</c:v>
                </c:pt>
                <c:pt idx="171">
                  <c:v>26.8381559</c:v>
                </c:pt>
                <c:pt idx="172">
                  <c:v>29.41954943</c:v>
                </c:pt>
                <c:pt idx="173">
                  <c:v>27.153034630000001</c:v>
                </c:pt>
                <c:pt idx="174">
                  <c:v>29.215625039999999</c:v>
                </c:pt>
                <c:pt idx="175">
                  <c:v>26.96753704</c:v>
                </c:pt>
                <c:pt idx="176">
                  <c:v>26.857371740000001</c:v>
                </c:pt>
                <c:pt idx="177">
                  <c:v>29.584403340000001</c:v>
                </c:pt>
                <c:pt idx="178">
                  <c:v>30.700252460000002</c:v>
                </c:pt>
                <c:pt idx="179">
                  <c:v>28.573240720000001</c:v>
                </c:pt>
                <c:pt idx="180">
                  <c:v>30.15547815</c:v>
                </c:pt>
                <c:pt idx="181">
                  <c:v>28.325041120000002</c:v>
                </c:pt>
                <c:pt idx="182">
                  <c:v>29.56547226</c:v>
                </c:pt>
                <c:pt idx="183">
                  <c:v>28.531917920000001</c:v>
                </c:pt>
                <c:pt idx="184">
                  <c:v>30.238389829999999</c:v>
                </c:pt>
                <c:pt idx="185">
                  <c:v>28.307340549999999</c:v>
                </c:pt>
                <c:pt idx="186">
                  <c:v>29.167187330000001</c:v>
                </c:pt>
                <c:pt idx="187">
                  <c:v>28.918766659999999</c:v>
                </c:pt>
                <c:pt idx="188">
                  <c:v>30.232959940000001</c:v>
                </c:pt>
                <c:pt idx="189">
                  <c:v>28.68140103</c:v>
                </c:pt>
                <c:pt idx="190">
                  <c:v>30.830567210000002</c:v>
                </c:pt>
                <c:pt idx="191">
                  <c:v>27.2570905</c:v>
                </c:pt>
                <c:pt idx="192">
                  <c:v>31.13654828</c:v>
                </c:pt>
                <c:pt idx="193">
                  <c:v>24.656340279999998</c:v>
                </c:pt>
                <c:pt idx="194">
                  <c:v>27.312988829999998</c:v>
                </c:pt>
                <c:pt idx="195">
                  <c:v>28.966555190000001</c:v>
                </c:pt>
                <c:pt idx="196">
                  <c:v>29.93304659</c:v>
                </c:pt>
                <c:pt idx="197">
                  <c:v>27.17276212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BCB-40FD-860F-F4934F3C13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4125368"/>
        <c:axId val="274130464"/>
      </c:scatterChart>
      <c:valAx>
        <c:axId val="274125368"/>
        <c:scaling>
          <c:orientation val="minMax"/>
          <c:min val="25"/>
        </c:scaling>
        <c:delete val="0"/>
        <c:axPos val="b"/>
        <c:title>
          <c:tx>
            <c:rich>
              <a:bodyPr/>
              <a:lstStyle/>
              <a:p>
                <a:pPr>
                  <a:defRPr sz="1200" b="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12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iber</a:t>
                </a:r>
                <a:r>
                  <a:rPr lang="en-US" sz="1200" b="0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lengths predicted with the </a:t>
                </a:r>
                <a:r>
                  <a:rPr lang="en-US" sz="12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5</a:t>
                </a:r>
                <a:r>
                  <a:rPr lang="en-US" sz="1200" b="0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elected </a:t>
                </a:r>
                <a:r>
                  <a:rPr lang="en-US" sz="1200" b="0" i="1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FL</a:t>
                </a:r>
                <a:r>
                  <a:rPr lang="en-US" sz="1200" b="0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genes (the SVMRGF model)</a:t>
                </a:r>
                <a:endParaRPr lang="en-US" sz="1200" b="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15741533166588564"/>
              <c:y val="0.87821459243674416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274130464"/>
        <c:crosses val="autoZero"/>
        <c:crossBetween val="midCat"/>
        <c:majorUnit val="1"/>
      </c:valAx>
      <c:valAx>
        <c:axId val="274130464"/>
        <c:scaling>
          <c:orientation val="minMax"/>
          <c:min val="24"/>
        </c:scaling>
        <c:delete val="0"/>
        <c:axPos val="l"/>
        <c:title>
          <c:tx>
            <c:rich>
              <a:bodyPr/>
              <a:lstStyle/>
              <a:p>
                <a:pPr>
                  <a:defRPr sz="1200" b="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12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Fiber lengths predicted with the 474</a:t>
                </a:r>
                <a:r>
                  <a:rPr lang="en-US" sz="1200" b="0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200" b="0" i="1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FL</a:t>
                </a:r>
                <a:r>
                  <a:rPr lang="en-US" sz="1200" b="0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genes     (the PLS model)</a:t>
                </a:r>
                <a:endParaRPr lang="en-US" sz="1200" b="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5.5752310483300101E-3"/>
              <c:y val="5.4618104542867488E-2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274125368"/>
        <c:crosses val="autoZero"/>
        <c:crossBetween val="midCat"/>
      </c:valAx>
      <c:spPr>
        <a:ln>
          <a:solidFill>
            <a:sysClr val="windowText" lastClr="000000">
              <a:lumMod val="65000"/>
              <a:lumOff val="35000"/>
            </a:sysClr>
          </a:solidFill>
        </a:ln>
      </c:spPr>
    </c:plotArea>
    <c:plotVisOnly val="1"/>
    <c:dispBlanksAs val="gap"/>
    <c:showDLblsOverMax val="0"/>
  </c:chart>
  <c:externalData r:id="rId2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9F68CD-90C4-7748-8CEA-A390B91AC6EF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BFDD35-CC67-FC44-BD99-08DD78BBA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65680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E4DEA8-D882-B641-883F-47F659727EB0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138FEA-BD44-E842-97FF-1F7DD025F3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5585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B138FEA-BD44-E842-97FF-1F7DD025F3C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8044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302201-B76E-984E-B12B-F18840886DDF}" type="datetimeFigureOut">
              <a:rPr lang="en-US" smtClean="0"/>
              <a:t>9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961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6462056"/>
              </p:ext>
            </p:extLst>
          </p:nvPr>
        </p:nvGraphicFramePr>
        <p:xfrm>
          <a:off x="2329905" y="1050572"/>
          <a:ext cx="4555865" cy="40252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Rectangle 2"/>
          <p:cNvSpPr/>
          <p:nvPr/>
        </p:nvSpPr>
        <p:spPr>
          <a:xfrm>
            <a:off x="2208732" y="5075849"/>
            <a:ext cx="501077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rrelation of predicted fiber lengths between the 125 selected </a:t>
            </a:r>
            <a:r>
              <a:rPr lang="en-US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FL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enes and all 474 </a:t>
            </a:r>
            <a:r>
              <a:rPr lang="en-US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FL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enes. The expression profiles of these genes and the optimal model for each set of the </a:t>
            </a:r>
            <a:r>
              <a:rPr lang="en-US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FL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enes were used for the prediction.</a:t>
            </a:r>
          </a:p>
        </p:txBody>
      </p:sp>
    </p:spTree>
    <p:extLst>
      <p:ext uri="{BB962C8B-B14F-4D97-AF65-F5344CB8AC3E}">
        <p14:creationId xmlns:p14="http://schemas.microsoft.com/office/powerpoint/2010/main" val="11442271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562</TotalTime>
  <Words>72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for cotton GBB manuscript</dc:title>
  <dc:creator>ellyce Liu</dc:creator>
  <cp:lastModifiedBy>Zhang, Hongbin</cp:lastModifiedBy>
  <cp:revision>308</cp:revision>
  <cp:lastPrinted>2017-01-23T15:43:11Z</cp:lastPrinted>
  <dcterms:created xsi:type="dcterms:W3CDTF">2017-01-04T23:35:27Z</dcterms:created>
  <dcterms:modified xsi:type="dcterms:W3CDTF">2020-09-22T19:39:03Z</dcterms:modified>
</cp:coreProperties>
</file>